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handoutMasterIdLst>
    <p:handoutMasterId r:id="rId12"/>
  </p:handoutMasterIdLst>
  <p:sldIdLst>
    <p:sldId id="751" r:id="rId2"/>
    <p:sldId id="747" r:id="rId3"/>
    <p:sldId id="743" r:id="rId4"/>
    <p:sldId id="744" r:id="rId5"/>
    <p:sldId id="746" r:id="rId6"/>
    <p:sldId id="745" r:id="rId7"/>
    <p:sldId id="752" r:id="rId8"/>
    <p:sldId id="754" r:id="rId9"/>
    <p:sldId id="748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2" frameSlides="1"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329" autoAdjust="0"/>
    <p:restoredTop sz="94646"/>
  </p:normalViewPr>
  <p:slideViewPr>
    <p:cSldViewPr>
      <p:cViewPr varScale="1">
        <p:scale>
          <a:sx n="94" d="100"/>
          <a:sy n="94" d="100"/>
        </p:scale>
        <p:origin x="424" y="19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handoutMaster" Target="handoutMasters/handout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635FFF-409D-6A48-97D5-97E02E9566E7}" type="datetimeFigureOut">
              <a:rPr lang="en-US" smtClean="0"/>
              <a:t>3/27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B44FDA-77C7-7D43-84C1-9853D95AA43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78947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56949D2-EF2E-4E3C-94BC-7845EBCB1DB8}" type="datetimeFigureOut">
              <a:rPr lang="en-US" smtClean="0"/>
              <a:pPr/>
              <a:t>3/27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217D741-8CEB-454D-A0C6-2ED849EFF217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88791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B3ED0-6197-4C69-B73E-3A43BF40B18C}" type="datetimeFigureOut">
              <a:rPr lang="en-US" smtClean="0"/>
              <a:pPr/>
              <a:t>3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1D39-D6C3-4D57-A301-68467A951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B3ED0-6197-4C69-B73E-3A43BF40B18C}" type="datetimeFigureOut">
              <a:rPr lang="en-US" smtClean="0"/>
              <a:pPr/>
              <a:t>3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1D39-D6C3-4D57-A301-68467A951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B3ED0-6197-4C69-B73E-3A43BF40B18C}" type="datetimeFigureOut">
              <a:rPr lang="en-US" smtClean="0"/>
              <a:pPr/>
              <a:t>3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1D39-D6C3-4D57-A301-68467A951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B3ED0-6197-4C69-B73E-3A43BF40B18C}" type="datetimeFigureOut">
              <a:rPr lang="en-US" smtClean="0"/>
              <a:pPr/>
              <a:t>3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1D39-D6C3-4D57-A301-68467A951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B3ED0-6197-4C69-B73E-3A43BF40B18C}" type="datetimeFigureOut">
              <a:rPr lang="en-US" smtClean="0"/>
              <a:pPr/>
              <a:t>3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1D39-D6C3-4D57-A301-68467A951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B3ED0-6197-4C69-B73E-3A43BF40B18C}" type="datetimeFigureOut">
              <a:rPr lang="en-US" smtClean="0"/>
              <a:pPr/>
              <a:t>3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1D39-D6C3-4D57-A301-68467A951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B3ED0-6197-4C69-B73E-3A43BF40B18C}" type="datetimeFigureOut">
              <a:rPr lang="en-US" smtClean="0"/>
              <a:pPr/>
              <a:t>3/27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1D39-D6C3-4D57-A301-68467A951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B3ED0-6197-4C69-B73E-3A43BF40B18C}" type="datetimeFigureOut">
              <a:rPr lang="en-US" smtClean="0"/>
              <a:pPr/>
              <a:t>3/27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1D39-D6C3-4D57-A301-68467A951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B3ED0-6197-4C69-B73E-3A43BF40B18C}" type="datetimeFigureOut">
              <a:rPr lang="en-US" smtClean="0"/>
              <a:pPr/>
              <a:t>3/27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1D39-D6C3-4D57-A301-68467A951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B3ED0-6197-4C69-B73E-3A43BF40B18C}" type="datetimeFigureOut">
              <a:rPr lang="en-US" smtClean="0"/>
              <a:pPr/>
              <a:t>3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1D39-D6C3-4D57-A301-68467A951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1B3ED0-6197-4C69-B73E-3A43BF40B18C}" type="datetimeFigureOut">
              <a:rPr lang="en-US" smtClean="0"/>
              <a:pPr/>
              <a:t>3/27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211D39-D6C3-4D57-A301-68467A951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1B3ED0-6197-4C69-B73E-3A43BF40B18C}" type="datetimeFigureOut">
              <a:rPr lang="en-US" smtClean="0"/>
              <a:pPr/>
              <a:t>3/27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211D39-D6C3-4D57-A301-68467A9515FA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A8375E05-D6F8-824C-B6F9-ED63821077CB}"/>
              </a:ext>
            </a:extLst>
          </p:cNvPr>
          <p:cNvSpPr txBox="1"/>
          <p:nvPr/>
        </p:nvSpPr>
        <p:spPr>
          <a:xfrm>
            <a:off x="228600" y="2399437"/>
            <a:ext cx="8686800" cy="8771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3300" b="1" dirty="0"/>
              <a:t>Supplementary Figures</a:t>
            </a:r>
            <a:endParaRPr lang="en-US" sz="3300" dirty="0"/>
          </a:p>
          <a:p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357326202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A8375E05-D6F8-824C-B6F9-ED63821077CB}"/>
              </a:ext>
            </a:extLst>
          </p:cNvPr>
          <p:cNvSpPr txBox="1"/>
          <p:nvPr/>
        </p:nvSpPr>
        <p:spPr>
          <a:xfrm>
            <a:off x="35257" y="36394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S1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5236E94-BA15-BB4C-8B2A-1415B67B75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76400" y="685800"/>
            <a:ext cx="5943600" cy="5943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326549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A8375E05-D6F8-824C-B6F9-ED63821077CB}"/>
              </a:ext>
            </a:extLst>
          </p:cNvPr>
          <p:cNvSpPr txBox="1"/>
          <p:nvPr/>
        </p:nvSpPr>
        <p:spPr>
          <a:xfrm>
            <a:off x="35257" y="36394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S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36DDD58-5956-8443-8699-D36E529CCAD9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2600" y="762000"/>
            <a:ext cx="5486400" cy="548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8556678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A8375E05-D6F8-824C-B6F9-ED63821077CB}"/>
              </a:ext>
            </a:extLst>
          </p:cNvPr>
          <p:cNvSpPr txBox="1"/>
          <p:nvPr/>
        </p:nvSpPr>
        <p:spPr>
          <a:xfrm>
            <a:off x="35257" y="36394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S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B2057C55-5E37-964A-9D49-468FC17F05A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5000" y="838200"/>
            <a:ext cx="5486400" cy="548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446495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A8375E05-D6F8-824C-B6F9-ED63821077CB}"/>
              </a:ext>
            </a:extLst>
          </p:cNvPr>
          <p:cNvSpPr txBox="1"/>
          <p:nvPr/>
        </p:nvSpPr>
        <p:spPr>
          <a:xfrm>
            <a:off x="35257" y="36394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S4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160A89B0-9B87-274C-A1FB-D637BF17D45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800" y="838200"/>
            <a:ext cx="5486400" cy="548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572299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A8375E05-D6F8-824C-B6F9-ED63821077CB}"/>
              </a:ext>
            </a:extLst>
          </p:cNvPr>
          <p:cNvSpPr txBox="1"/>
          <p:nvPr/>
        </p:nvSpPr>
        <p:spPr>
          <a:xfrm>
            <a:off x="35257" y="36394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S5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BDD1DC7-8D0C-C84E-BC94-3BEAB6B310F1}"/>
              </a:ext>
            </a:extLst>
          </p:cNvPr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400" y="1295400"/>
            <a:ext cx="8869680" cy="4114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762752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A8375E05-D6F8-824C-B6F9-ED63821077CB}"/>
              </a:ext>
            </a:extLst>
          </p:cNvPr>
          <p:cNvSpPr txBox="1"/>
          <p:nvPr/>
        </p:nvSpPr>
        <p:spPr>
          <a:xfrm>
            <a:off x="35257" y="36394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S</a:t>
            </a:r>
            <a:r>
              <a:rPr lang="en-US" altLang="zh-TW" b="1" dirty="0"/>
              <a:t>6</a:t>
            </a:r>
            <a:endParaRPr lang="en-US" b="1" dirty="0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5FED68F-B60A-BF4F-A7F7-F70648252A2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8200" y="457200"/>
            <a:ext cx="7467600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2394909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A8375E05-D6F8-824C-B6F9-ED63821077CB}"/>
              </a:ext>
            </a:extLst>
          </p:cNvPr>
          <p:cNvSpPr txBox="1"/>
          <p:nvPr/>
        </p:nvSpPr>
        <p:spPr>
          <a:xfrm>
            <a:off x="35257" y="36394"/>
            <a:ext cx="99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S7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2524771-0EDE-2347-8476-4E7FD461B96C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52600" y="914400"/>
            <a:ext cx="5486400" cy="54864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042928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A8375E05-D6F8-824C-B6F9-ED63821077CB}"/>
              </a:ext>
            </a:extLst>
          </p:cNvPr>
          <p:cNvSpPr txBox="1"/>
          <p:nvPr/>
        </p:nvSpPr>
        <p:spPr>
          <a:xfrm>
            <a:off x="35256" y="36394"/>
            <a:ext cx="13363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Fig. S8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A24B76CD-A798-5644-995B-990A4B1FFBEB}"/>
              </a:ext>
            </a:extLst>
          </p:cNvPr>
          <p:cNvPicPr>
            <a:picLocks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400" y="304800"/>
            <a:ext cx="7315200" cy="6400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411751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9549</TotalTime>
  <Words>26</Words>
  <Application>Microsoft Macintosh PowerPoint</Application>
  <PresentationFormat>On-screen Show (4:3)</PresentationFormat>
  <Paragraphs>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3" baseType="lpstr">
      <vt:lpstr>新細明體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per</dc:creator>
  <cp:lastModifiedBy>Microsoft Office User</cp:lastModifiedBy>
  <cp:revision>1386</cp:revision>
  <cp:lastPrinted>2016-10-26T16:03:13Z</cp:lastPrinted>
  <dcterms:created xsi:type="dcterms:W3CDTF">2015-05-08T16:39:44Z</dcterms:created>
  <dcterms:modified xsi:type="dcterms:W3CDTF">2020-04-15T18:31:37Z</dcterms:modified>
</cp:coreProperties>
</file>